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D53A4E-9FF4-409B-B395-49835F7B6A4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67A468-7FD6-48A4-8D46-23049D1FA4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341DE-743C-4837-8682-910F1791EB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920536-6AE1-48BD-815F-87FE81BCABA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B8B875-D500-450D-BB8B-7868C1D7C2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F5451C-EE49-4443-88C9-7AA01F4DFE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80287-9962-40F3-A6A3-7C6E0381ED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909A5-8BC3-480E-BA51-0E4E933DFA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8946C9-C7FD-41D2-B65B-E5BCC9351A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AEF0B9-ADF0-4AC4-8EF0-41BF589ECF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07F93B-FAC8-4122-B701-1EA1D3B40D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0B252F-2F19-466E-AA95-2281D6FF41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2EDCEE-B002-4B8F-A553-43792BCA29A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image" Target="../media/image11.png"/><Relationship Id="rId7" Type="http://schemas.openxmlformats.org/officeDocument/2006/relationships/image" Target="../media/image12.png"/><Relationship Id="rId8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058840" y="1508040"/>
            <a:ext cx="5057640" cy="374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A0110w ring-infected erythrocyte surface antigen precursor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A0660w protein with DNAJ domain, dnj1/sis1 family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B0915w liver stage antigen 3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D1170c hypothetical protein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E0120c merozoite surface protein 8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MAL7P1.27 chloroquine resistance transporter, putative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MAL7P1.7 RESA-like protein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10_0025 PF70 protein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10_0019 early transcribed membrane protein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11_0512 ring-infected erythrocyte surface antigen 2, RESA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11_0509 ring-infected erythrocyte surface antigen, putative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11_0513 hypothetical protein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11_0040 early transcribed membrane protein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11_0039 early transcribed membrane protein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L0035c octapeptide-repeat antigen, putative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14_0075 plasmepsin, putative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14_0553 trophozoite cysteine proteinase precursor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14_0016 hypothetical protein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14_0076 plasmepsin 1 precursor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MAL7P1.170 ring stage expressed protein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E0070w interspersed repeat antigen, putative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07_0006 starp antigen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I0590c hypothetical protein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PFE1150w multidrug resistance protein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501720" y="76320"/>
            <a:ext cx="2084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"/>
              </a:rPr>
              <a:t>Early Ring Transcrip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"/>
              </a:rPr>
              <a:t>(24 gene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7EC802-64D6-46D9-A14A-F27386928D70}" type="slidenum">
              <a:t>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"/>
          <p:cNvGrpSpPr/>
          <p:nvPr/>
        </p:nvGrpSpPr>
        <p:grpSpPr>
          <a:xfrm>
            <a:off x="0" y="152280"/>
            <a:ext cx="4774680" cy="4024080"/>
            <a:chOff x="0" y="152280"/>
            <a:chExt cx="4774680" cy="4024080"/>
          </a:xfrm>
        </p:grpSpPr>
        <p:pic>
          <p:nvPicPr>
            <p:cNvPr id="44" name="" descr=""/>
            <p:cNvPicPr/>
            <p:nvPr/>
          </p:nvPicPr>
          <p:blipFill>
            <a:blip r:embed="rId1"/>
            <a:srcRect l="1412" t="2553" r="0" b="5107"/>
            <a:stretch/>
          </p:blipFill>
          <p:spPr>
            <a:xfrm>
              <a:off x="0" y="1195200"/>
              <a:ext cx="2971800" cy="771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"/>
            <p:cNvSpPr/>
            <p:nvPr/>
          </p:nvSpPr>
          <p:spPr>
            <a:xfrm>
              <a:off x="12600" y="1066680"/>
              <a:ext cx="3492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MEME, 2ring_uig, 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 Unicode MS"/>
                  <a:ea typeface="Times New Roman"/>
                </a:rPr>
                <a:t>anr2, </a:t>
              </a:r>
              <a:r>
                <a:rPr b="0" lang="it-IT" sz="800" spc="-1" strike="noStrike">
                  <a:solidFill>
                    <a:srgbClr val="000000"/>
                  </a:solidFill>
                  <a:latin typeface="Arial Unicode MS"/>
                </a:rPr>
                <a:t>ACACATTACCA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 Unicode MS"/>
                  <a:ea typeface="Times New Roman"/>
                </a:rPr>
                <a:t>, </a:t>
              </a:r>
              <a:r>
                <a:rPr b="0" lang="it-IT" sz="800" spc="-1" strike="noStrike">
                  <a:solidFill>
                    <a:srgbClr val="000000"/>
                  </a:solidFill>
                  <a:latin typeface="Arial Unicode MS"/>
                </a:rPr>
                <a:t>w=11,s=17,llr=197,E=4.3e-002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6" name="" descr=""/>
            <p:cNvPicPr/>
            <p:nvPr/>
          </p:nvPicPr>
          <p:blipFill>
            <a:blip r:embed="rId2"/>
            <a:srcRect l="1412" t="2553" r="0" b="5107"/>
            <a:stretch/>
          </p:blipFill>
          <p:spPr>
            <a:xfrm>
              <a:off x="762120" y="263160"/>
              <a:ext cx="3041640" cy="789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"/>
            <p:cNvSpPr/>
            <p:nvPr/>
          </p:nvSpPr>
          <p:spPr>
            <a:xfrm>
              <a:off x="388080" y="152280"/>
              <a:ext cx="3643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MEME, 2ring_uig, 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 Unicode MS"/>
                  <a:ea typeface="Times New Roman"/>
                </a:rPr>
                <a:t>zoops1,  </a:t>
              </a:r>
              <a:r>
                <a:rPr b="0" lang="nl-NL" sz="800" spc="-1" strike="noStrike">
                  <a:solidFill>
                    <a:srgbClr val="000000"/>
                  </a:solidFill>
                  <a:latin typeface="Arial Unicode MS"/>
                </a:rPr>
                <a:t>CCGAAAAAAAA,w=11,s=24,llr=248,E=2.3e-008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" descr=""/>
            <p:cNvPicPr/>
            <p:nvPr/>
          </p:nvPicPr>
          <p:blipFill>
            <a:blip r:embed="rId3"/>
            <a:srcRect l="1412" t="2553" r="0" b="5107"/>
            <a:stretch/>
          </p:blipFill>
          <p:spPr>
            <a:xfrm>
              <a:off x="425520" y="2068200"/>
              <a:ext cx="3962160" cy="102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"/>
            <p:cNvSpPr/>
            <p:nvPr/>
          </p:nvSpPr>
          <p:spPr>
            <a:xfrm>
              <a:off x="596880" y="1947600"/>
              <a:ext cx="379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AlignACE, 2ring_uig, 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 Unicode MS"/>
                </a:rPr>
                <a:t>CC-WW-AAAAAAAA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, 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 Unicode MS"/>
                </a:rPr>
                <a:t>1.4e+01 1.1e-03 7.2e-03 446 s=16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" descr=""/>
            <p:cNvPicPr/>
            <p:nvPr/>
          </p:nvPicPr>
          <p:blipFill>
            <a:blip r:embed="rId4"/>
            <a:srcRect l="1412" t="2553" r="0" b="5107"/>
            <a:stretch/>
          </p:blipFill>
          <p:spPr>
            <a:xfrm>
              <a:off x="654120" y="3152520"/>
              <a:ext cx="3962160" cy="1023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"/>
            <p:cNvSpPr/>
            <p:nvPr/>
          </p:nvSpPr>
          <p:spPr>
            <a:xfrm>
              <a:off x="963720" y="3090600"/>
              <a:ext cx="381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AlignACE, 2ring_uig, 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 Unicode MS"/>
                </a:rPr>
                <a:t>CATRCA-AWAAWAW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 , 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 Unicode MS"/>
                </a:rPr>
                <a:t>1.4e+01 3.3e-05 1.7e-02 157 s=8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" name=""/>
          <p:cNvSpPr/>
          <p:nvPr/>
        </p:nvSpPr>
        <p:spPr>
          <a:xfrm>
            <a:off x="5214600" y="3705840"/>
            <a:ext cx="3753720" cy="201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EME, anr2; weakly related to zoops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07_0006;  1831  1.21e-07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0_0019;  53    1.37e-07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27;  210   1.97e-07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039;  488   2.82e-07   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C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512;  1463  3.18e-07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27;  1878  3.53e-07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07_0006;  1347  5.65e-07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T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27;  1930  5.65e-07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040;  1660  1.12e-06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27;  316   1.52e-06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040;  326   3.43e-06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7;   1963  3.43e-06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076;  1763  3.75e-06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7;   727   4.08e-06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B0915w;   1591  4.08e-06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D1170c;   1661  7.17e-06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076;  1890  8.58e-06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213880" y="826920"/>
            <a:ext cx="3755160" cy="275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EME, zoops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0_0019;  1351  8.97e-08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0070w;   1113  1.46e-07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C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07_0006;  1965  2.67e-07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0660w;   1825  2.98e-07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513;  178   4.49e-07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L0035c;   581   5.20e-07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512;  178   6.60e-07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B0915w;   1594  1.35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7;   1520  1.51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509;  130   2.23e-06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075;  1943  3.58e-06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A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040;  104   5.23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016;  826   8.22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0110w;   1679  8.98e-06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076;  1565  1.01e-05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0120c;   804   1.34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I0590c;   167   1.50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T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170; 1511  1.79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0_0025;  1925  1.97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D1170c;   1080  2.31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039;  478   2.73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1150w;   1565  4.04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553;  5     4.42e-05      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27;  451   4.42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117080" y="4513680"/>
            <a:ext cx="1994400" cy="211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lignAC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-WW-AAAAAAAAA; weakly related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o zoops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2       108 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2       1116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4       803   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7       51  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7       910   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8       1620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9       1369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13      1448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15      1942  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16      660 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17      733 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18      229 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18      1051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20      479 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C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20      1112  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21      1031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6320" y="4081320"/>
            <a:ext cx="1066680" cy="275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Key AlignAC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0       PFA011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       PFA066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2       PFB0915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3       PFD1170c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4       PFE0120c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5       MAL7P1.27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6       MAL7P1.7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7       PF10_0025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8       PF10_0019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9       PF11_0512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0     PF11_0509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1     PF11_0513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2     PF11_0040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3     PF11_0039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4     PFL0035c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5     PF14_0075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6     PF14_0553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7     PF14_0016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8     PF14_0076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9     MAL7P1.170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20     PFE007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21     PF07_0006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22     PFI0590c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23     PFE115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136680" y="5114520"/>
            <a:ext cx="2047680" cy="12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lignAC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ATRCA-AWAAWAWA; weakly related to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-WW-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AAAA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1       1735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2       269 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6       1252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7       911   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7       1166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8       909 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14      519 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20      860 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362680" y="4343400"/>
            <a:ext cx="92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o strong motif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276160" y="76320"/>
            <a:ext cx="37101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990099"/>
                </a:solidFill>
                <a:latin typeface="Arial"/>
              </a:rPr>
              <a:t>Early Ring Transcripts - Motif1 -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990099"/>
                </a:solidFill>
                <a:latin typeface="Arial"/>
              </a:rPr>
              <a:t>weakly related; no strong motif identifie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990099"/>
                </a:solidFill>
                <a:latin typeface="Arial"/>
              </a:rPr>
              <a:t>for the set of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B43AFC-48F7-4C0D-BB93-2A682FC03373}" type="slidenum">
              <a:t>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rcRect l="1137" t="976" r="19336" b="976"/>
          <a:stretch/>
        </p:blipFill>
        <p:spPr>
          <a:xfrm>
            <a:off x="685800" y="0"/>
            <a:ext cx="4772160" cy="685800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>
            <a:off x="6088680" y="152280"/>
            <a:ext cx="2062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990099"/>
                </a:solidFill>
                <a:latin typeface="Arial"/>
              </a:rPr>
              <a:t>Occurrences of Motif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1F519-0032-46AE-A9CB-7C72B72F2DBD}" type="slidenum">
              <a:t>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"/>
          <p:cNvGrpSpPr/>
          <p:nvPr/>
        </p:nvGrpSpPr>
        <p:grpSpPr>
          <a:xfrm>
            <a:off x="0" y="804960"/>
            <a:ext cx="4129200" cy="5290560"/>
            <a:chOff x="0" y="804960"/>
            <a:chExt cx="4129200" cy="5290560"/>
          </a:xfrm>
        </p:grpSpPr>
        <p:pic>
          <p:nvPicPr>
            <p:cNvPr id="62" name="" descr=""/>
            <p:cNvPicPr/>
            <p:nvPr/>
          </p:nvPicPr>
          <p:blipFill>
            <a:blip r:embed="rId1"/>
            <a:srcRect l="1412" t="2553" r="0" b="5107"/>
            <a:stretch/>
          </p:blipFill>
          <p:spPr>
            <a:xfrm>
              <a:off x="380880" y="804960"/>
              <a:ext cx="3657600" cy="947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"/>
            <p:cNvSpPr/>
            <p:nvPr/>
          </p:nvSpPr>
          <p:spPr>
            <a:xfrm>
              <a:off x="689040" y="907920"/>
              <a:ext cx="3279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MEME, 2ring_uig, 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 Unicode MS"/>
                  <a:ea typeface="Times New Roman"/>
                </a:rPr>
                <a:t>anr1, 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 Unicode MS"/>
                </a:rPr>
                <a:t>GTGGTAGC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 Unicode MS"/>
                  <a:ea typeface="Times New Roman"/>
                </a:rPr>
                <a:t>, 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 Unicode MS"/>
                </a:rPr>
                <a:t>w=8,s=33,llr=315,E=8.1e-004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4" name="" descr=""/>
            <p:cNvPicPr/>
            <p:nvPr/>
          </p:nvPicPr>
          <p:blipFill>
            <a:blip r:embed="rId2"/>
            <a:srcRect l="1412" t="2553" r="0" b="5107"/>
            <a:stretch/>
          </p:blipFill>
          <p:spPr>
            <a:xfrm>
              <a:off x="1219320" y="1860480"/>
              <a:ext cx="2819160" cy="729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"/>
            <p:cNvSpPr/>
            <p:nvPr/>
          </p:nvSpPr>
          <p:spPr>
            <a:xfrm>
              <a:off x="914760" y="1752480"/>
              <a:ext cx="320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MEME, 2ring_uig, 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 Unicode MS"/>
                  <a:ea typeface="Times New Roman"/>
                </a:rPr>
                <a:t>zoops2, 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 Unicode MS"/>
                </a:rPr>
                <a:t>GGTACC,w=6,s=24,llr=218,E=5.4e-00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6" name="" descr=""/>
            <p:cNvPicPr/>
            <p:nvPr/>
          </p:nvPicPr>
          <p:blipFill>
            <a:blip r:embed="rId3"/>
            <a:srcRect l="1412" t="2553" r="0" b="5107"/>
            <a:stretch/>
          </p:blipFill>
          <p:spPr>
            <a:xfrm>
              <a:off x="0" y="3538440"/>
              <a:ext cx="2814480" cy="728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" name=""/>
            <p:cNvSpPr/>
            <p:nvPr/>
          </p:nvSpPr>
          <p:spPr>
            <a:xfrm>
              <a:off x="238680" y="3463920"/>
              <a:ext cx="233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Weeder, 2ring_uig, TGCGGT, 0.75, s=7(@1,9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8" name="" descr=""/>
            <p:cNvPicPr/>
            <p:nvPr/>
          </p:nvPicPr>
          <p:blipFill>
            <a:blip r:embed="rId4"/>
            <a:srcRect l="1412" t="2553" r="0" b="5107"/>
            <a:stretch/>
          </p:blipFill>
          <p:spPr>
            <a:xfrm>
              <a:off x="0" y="2698560"/>
              <a:ext cx="2814480" cy="730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"/>
            <p:cNvSpPr/>
            <p:nvPr/>
          </p:nvSpPr>
          <p:spPr>
            <a:xfrm>
              <a:off x="236880" y="2590560"/>
              <a:ext cx="2402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Weeder, 2ring_uig, AGCGGT, 0.64, s=13(@1,9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0" name="" descr=""/>
            <p:cNvPicPr/>
            <p:nvPr/>
          </p:nvPicPr>
          <p:blipFill>
            <a:blip r:embed="rId5"/>
            <a:srcRect l="1412" t="2553" r="0" b="5107"/>
            <a:stretch/>
          </p:blipFill>
          <p:spPr>
            <a:xfrm>
              <a:off x="914400" y="4476600"/>
              <a:ext cx="2666880" cy="690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"/>
            <p:cNvSpPr/>
            <p:nvPr/>
          </p:nvSpPr>
          <p:spPr>
            <a:xfrm>
              <a:off x="1074240" y="4343400"/>
              <a:ext cx="2439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Weeder, 2ring_uig,  GGGTAG, 0.66, s=12(@0,95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2" name="" descr=""/>
            <p:cNvPicPr/>
            <p:nvPr/>
          </p:nvPicPr>
          <p:blipFill>
            <a:blip r:embed="rId6"/>
            <a:srcRect l="1412" t="2553" r="0" b="5107"/>
            <a:stretch/>
          </p:blipFill>
          <p:spPr>
            <a:xfrm>
              <a:off x="914400" y="5284800"/>
              <a:ext cx="3124080" cy="81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3" name=""/>
            <p:cNvSpPr/>
            <p:nvPr/>
          </p:nvSpPr>
          <p:spPr>
            <a:xfrm>
              <a:off x="839520" y="5257800"/>
              <a:ext cx="3289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MEME, 2ring_uig, 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 Unicode MS"/>
                  <a:ea typeface="Times New Roman"/>
                </a:rPr>
                <a:t>zoops3, 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 Unicode MS"/>
                </a:rPr>
                <a:t>TGCATGA,w=7,s=24,llr=222,E=1.8e-005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" name=""/>
          <p:cNvSpPr/>
          <p:nvPr/>
        </p:nvSpPr>
        <p:spPr>
          <a:xfrm>
            <a:off x="215280" y="0"/>
            <a:ext cx="39877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990099"/>
                </a:solidFill>
                <a:latin typeface="Arial"/>
              </a:rPr>
              <a:t>Early Ring Transcripts - Motif2 - weakl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990099"/>
                </a:solidFill>
                <a:latin typeface="Arial"/>
              </a:rPr>
              <a:t>related; no strong motif identified for the se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990099"/>
                </a:solidFill>
                <a:latin typeface="Arial"/>
              </a:rPr>
              <a:t>of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" descr=""/>
          <p:cNvPicPr/>
          <p:nvPr/>
        </p:nvPicPr>
        <p:blipFill>
          <a:blip r:embed="rId7"/>
          <a:srcRect l="1197" t="972" r="15561" b="972"/>
          <a:stretch/>
        </p:blipFill>
        <p:spPr>
          <a:xfrm>
            <a:off x="4343400" y="0"/>
            <a:ext cx="4724280" cy="6858000"/>
          </a:xfrm>
          <a:prstGeom prst="rect">
            <a:avLst/>
          </a:prstGeom>
          <a:ln w="0">
            <a:noFill/>
          </a:ln>
        </p:spPr>
      </p:pic>
      <p:sp>
        <p:nvSpPr>
          <p:cNvPr id="76" name=""/>
          <p:cNvSpPr/>
          <p:nvPr/>
        </p:nvSpPr>
        <p:spPr>
          <a:xfrm>
            <a:off x="659880" y="6324480"/>
            <a:ext cx="3615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everal variants of the motif which are weakly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elated; too many occurrences; no striking featur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2BF1D0-A8C3-470A-A073-B22EF0F94666}" type="slidenum">
              <a:t>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"/>
          <p:cNvSpPr/>
          <p:nvPr/>
        </p:nvSpPr>
        <p:spPr>
          <a:xfrm>
            <a:off x="5562720" y="3501000"/>
            <a:ext cx="1752480" cy="211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Weed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weakly related to anr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en-US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en-US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en-US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en-US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- best occs. - 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substit,95% thresh (match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%age):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</a:t>
            </a:r>
            <a:r>
              <a:rPr b="1" lang="en-US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011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411, (96.37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066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978, (100.00)*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E0120c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036, (100.00)*+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M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27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591, (96.37)*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M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7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343, (96.37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11_0509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399, (96.37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14_0076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522, (100.00)*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39680" y="173520"/>
            <a:ext cx="3647880" cy="371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EME, anr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07_0006;  1803  2.39e-07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G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040;  513   7.76e-07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~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AL7P1.27;  1592  1.61e-06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040;  1179  1.91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~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AL7P1.7;   1556  2.29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1150w;   625   3.30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039;  799   3.30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A0660w;   83    3.30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I0590c;   935   6.08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07_0006;  707   6.08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016;  1904  6.08e-06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L0035c;   578   8.55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0_0019;  1349  9.48e-06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A0660w;   299   9.48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AL7P1.7;   508   1.01e-05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553;  80    1.32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A0660w;   1823  1.32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AL7P1.27;  9     1.63e-05  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*+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0120c;   1402  1.63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D1170c;   1878  1.63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0070w;   827   1.82e-05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07_0006;  455   1.93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0070w;   1651  1.93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07_0006;  172   2.51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AL7P1.7;   1846  2.51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512;  142   3.04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A0110w;   492   3.04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0_0025;  270   3.45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0120c;   1031  3.45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*+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553;  995   4.10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513;  1840  4.64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0_0019;  1289  4.64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0_0019;  1309  5.99e-05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73880" y="3951360"/>
            <a:ext cx="3487680" cy="275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EME, zoops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039;  1827  1.69e-06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0120c;   222   3.30e-06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016;  1906  6.77e-06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553;  82    6.77e-06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I0590c;   289   8.69e-06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27;  1594  8.69e-06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07_0006;  709   1.05e-05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0_0025;  215   1.36e-05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7;   1848  1.36e-05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D1170c;   654   1.36e-05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0110w;   1455  1.54e-05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0660w;   85    1.73e-05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040;  329   2.26e-05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0_0019;  1311  2.26e-05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0070w;   829   4.00e-05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L0035c;   1767  4.00e-05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513;  1551  4.00e-05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170; 840   6.33e-05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075;  596   6.33e-05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1150w;   816   6.69e-05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512;  1366  8.40e-05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076;  1048  9.95e-05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B0915w;   1113  9.95e-05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509;  1668  1.33e-04   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it-IT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</a:t>
            </a:r>
            <a:r>
              <a:rPr b="1" lang="it-IT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it-IT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886200" y="3472920"/>
            <a:ext cx="1752480" cy="329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Weed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related to TGCGGT; weakly related to anr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en-US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en-US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en-US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en-US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- best occs. - 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substit,95% thresh (match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%age):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</a:t>
            </a:r>
            <a:r>
              <a:rPr b="1" lang="en-US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011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358, (95.41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066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978, (95.41)*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D1170c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423, (95.41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E0120c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036, (95.41)*+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10_0019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496, (95.24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11_0509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226, (95.59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810, (95.24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584, (95.24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11_0039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994, (95.41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L0035c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784, (100.00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14_0016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338, (95.59)*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14_0076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522, (95.41)*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M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170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en-US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en-US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en-US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en-US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en-US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850, (95.59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7315200" y="3533400"/>
            <a:ext cx="1752480" cy="307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Weed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weakly related to anr1; related to AGCGGT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</a:t>
            </a:r>
            <a:r>
              <a:rPr b="1" lang="en-US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en-US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en-US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- best occs. - 1 substit,95% thresh (match %age):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</a:t>
            </a:r>
            <a:r>
              <a:rPr b="1" lang="en-US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066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819, (95.42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B0915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747, (95.79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M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27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1, (100.00)*+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M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7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914, (95.42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10_0025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538, (100.00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739, (95.79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11_0040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505, (95.42)~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185, (100.00)~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14_0016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340, (95.79)*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E007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1607, (95.79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07_0006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708, (95.79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&gt;PFI0590c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+  </a:t>
            </a:r>
            <a:r>
              <a:rPr b="1" lang="en-US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en-US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en-US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en-US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en-US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en-US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 936, (95.79)*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745880" y="750960"/>
            <a:ext cx="3541320" cy="275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EME, zoops3; related to anr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0_0025;  271   1.56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7;   1251  1.56e-06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0120c;   1032  1.56e-06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0110w;   436   2.59e-06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I0590c;   791   3.69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039;  405   3.69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040;  1180  3.69e-06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D1170c;   166   3.69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07_0006;  1803  6.71e-06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G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075;  538   1.95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513;  597   1.95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TTT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512;  656   1.95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016;  940   2.22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1_0509;  445   2.22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0070w;   975   3.47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0_0019;  1380  3.47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553;  995   4.31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27;  10    4.31e-05 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7P1.170; 440   5.18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0660w;   1209  5.18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L0035c;   13    6.19e-05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B0915w;   1660  6.19e-05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14_0076;  523   6.79e-05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FE1150w;   1038  3.00e-04   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TTTTTTT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635000" y="31680"/>
            <a:ext cx="39877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990099"/>
                </a:solidFill>
                <a:latin typeface="Arial"/>
              </a:rPr>
              <a:t>Early Ring Transcripts - Motif2 - weakl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990099"/>
                </a:solidFill>
                <a:latin typeface="Arial"/>
              </a:rPr>
              <a:t>related; no strong motif identified for the se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990099"/>
                </a:solidFill>
                <a:latin typeface="Arial"/>
              </a:rPr>
              <a:t>of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67973C-F202-4B72-A3FE-E343C92ECED6}" type="slidenum">
              <a:t>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"/>
          <p:cNvGrpSpPr/>
          <p:nvPr/>
        </p:nvGrpSpPr>
        <p:grpSpPr>
          <a:xfrm>
            <a:off x="43560" y="914400"/>
            <a:ext cx="4376160" cy="1905120"/>
            <a:chOff x="43560" y="914400"/>
            <a:chExt cx="4376160" cy="1905120"/>
          </a:xfrm>
        </p:grpSpPr>
        <p:pic>
          <p:nvPicPr>
            <p:cNvPr id="85" name="" descr=""/>
            <p:cNvPicPr/>
            <p:nvPr/>
          </p:nvPicPr>
          <p:blipFill>
            <a:blip r:embed="rId1"/>
            <a:srcRect l="1412" t="2553" r="0" b="5107"/>
            <a:stretch/>
          </p:blipFill>
          <p:spPr>
            <a:xfrm>
              <a:off x="152280" y="2225520"/>
              <a:ext cx="2286000" cy="59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"/>
            <p:cNvSpPr/>
            <p:nvPr/>
          </p:nvSpPr>
          <p:spPr>
            <a:xfrm>
              <a:off x="43560" y="2057400"/>
              <a:ext cx="3376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AlignACE, 2ring_uig, 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 Unicode MS"/>
                </a:rPr>
                <a:t>A-WAAAAWGG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, 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 Unicode MS"/>
                </a:rPr>
                <a:t>2.5e+01 3.5e-04 9.6e-04 4 s=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7" name="" descr=""/>
            <p:cNvPicPr/>
            <p:nvPr/>
          </p:nvPicPr>
          <p:blipFill>
            <a:blip r:embed="rId2"/>
            <a:srcRect l="1412" t="2553" r="0" b="5107"/>
            <a:stretch/>
          </p:blipFill>
          <p:spPr>
            <a:xfrm>
              <a:off x="903240" y="1069920"/>
              <a:ext cx="3516480" cy="911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8" name=""/>
            <p:cNvSpPr/>
            <p:nvPr/>
          </p:nvSpPr>
          <p:spPr>
            <a:xfrm>
              <a:off x="490680" y="914400"/>
              <a:ext cx="391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AlignACE, 2ring_uig, 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 Unicode MS"/>
                </a:rPr>
                <a:t>AAAAGG-AWAWAAAA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, 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 Unicode MS"/>
                </a:rPr>
                <a:t>3.6e+01 7.1e-04 3.3e-04 203 s=13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9" name=""/>
          <p:cNvSpPr/>
          <p:nvPr/>
        </p:nvSpPr>
        <p:spPr>
          <a:xfrm>
            <a:off x="76320" y="3182760"/>
            <a:ext cx="1143000" cy="275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Key - AlignAC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0       PFA011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       PFA066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2       PFB0915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3       PFD1170c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4       PFE0120c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5       MAL7P1.27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6       MAL7P1.7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7       PF10_0025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8       PF10_0019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9       PF11_0512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0     PF11_0509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1     PF11_0513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2     PF11_0040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3     PF11_0039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4     PFL0035c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5     PF14_0075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6     PF14_0553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7     PF14_0016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8     PF14_0076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19     MAL7P1.170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20     PFE007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21     PF07_0006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22     PFI0590c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#23     PFE1150w;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076400" y="3162240"/>
            <a:ext cx="1567800" cy="297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lignAC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-WAAAAWG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23   1458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21   50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21   33 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20   487 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9   902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9   355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8   505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5   1495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5   745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4   765 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4   634 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1   1336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1   1069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0   315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9    406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4    301 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4    212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2    1597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    1657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    1645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    1611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    1599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    1576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    1553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    717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2602440" y="3564720"/>
            <a:ext cx="1887840" cy="169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lignAC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AAAGG-AWAWAAA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    1557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    1580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    1603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    1649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3    1678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4    305 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4    625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1   615 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2   1906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4   637 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GG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14   768 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20   491   1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AAA</a:t>
            </a:r>
            <a:r>
              <a:rPr b="1" lang="fr-FR" sz="700" spc="-1" strike="noStrike">
                <a:solidFill>
                  <a:srgbClr val="ff9900"/>
                </a:solidFill>
                <a:latin typeface="Courier New"/>
                <a:ea typeface="Times New Roman"/>
              </a:rPr>
              <a:t>GG</a:t>
            </a:r>
            <a:r>
              <a:rPr b="1" lang="fr-FR" sz="700" spc="-1" strike="noStrike">
                <a:solidFill>
                  <a:srgbClr val="0000ff"/>
                </a:solidFill>
                <a:latin typeface="Courier New"/>
                <a:ea typeface="Times New Roman"/>
              </a:rPr>
              <a:t>C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T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1" lang="fr-FR" sz="700" spc="-1" strike="noStrike">
                <a:solidFill>
                  <a:srgbClr val="00cc00"/>
                </a:solidFill>
                <a:latin typeface="Courier New"/>
                <a:ea typeface="Times New Roman"/>
              </a:rPr>
              <a:t>A</a:t>
            </a:r>
            <a:r>
              <a:rPr b="1" lang="fr-FR" sz="7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  23   1392 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69000" y="76320"/>
            <a:ext cx="36799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990099"/>
                </a:solidFill>
                <a:latin typeface="Arial"/>
              </a:rPr>
              <a:t>Early Ring Transcripts - Motif3; weakl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990099"/>
                </a:solidFill>
                <a:latin typeface="Arial"/>
              </a:rPr>
              <a:t>related; no strong motif identified for th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990099"/>
                </a:solidFill>
                <a:latin typeface="Arial"/>
              </a:rPr>
              <a:t>set of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" descr=""/>
          <p:cNvPicPr/>
          <p:nvPr/>
        </p:nvPicPr>
        <p:blipFill>
          <a:blip r:embed="rId3"/>
          <a:srcRect l="1129" t="976" r="20329" b="976"/>
          <a:stretch/>
        </p:blipFill>
        <p:spPr>
          <a:xfrm>
            <a:off x="4489560" y="57240"/>
            <a:ext cx="4654440" cy="6724440"/>
          </a:xfrm>
          <a:prstGeom prst="rect">
            <a:avLst/>
          </a:prstGeom>
          <a:ln w="0">
            <a:noFill/>
          </a:ln>
        </p:spPr>
      </p:pic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04D8E1-C077-4935-B244-0FC9CF026065}" type="slidenum">
              <a:t>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52F988-3C2C-4AAC-A7F5-8C11C3829C1F}" type="slidenum">
              <a:t>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03T12:54:19Z</dcterms:created>
  <dc:creator>prathima iengar</dc:creator>
  <dc:description/>
  <dc:language>en-US</dc:language>
  <cp:lastModifiedBy>prathima iengar</cp:lastModifiedBy>
  <dcterms:modified xsi:type="dcterms:W3CDTF">2008-05-22T09:28:19Z</dcterms:modified>
  <cp:revision>13</cp:revision>
  <dc:subject/>
  <dc:title>Slide 1</dc:title>
</cp:coreProperties>
</file>